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43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056B7E-3853-4DEB-972F-204C26CE20B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AD810AD-A3DB-4F2A-8462-F1DCD3D2428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375C53-82AB-4BAE-A514-7FB6A3942B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AAF5D6B-0D29-4859-9B83-4161C51A2D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A63BFA-A7A2-4FBB-8B4A-BF3701EEA0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4586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1EBE33-9CD7-483D-8263-3E14E716163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F40E486-1E45-406D-94F6-F90F35D4859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35A4A3-9C05-46CA-B3A9-F95F9F55FE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A0CD0F1-C716-46B7-B58F-6EDBA7C3E9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0E9DC4-5C79-478F-8103-4BDE40213F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38984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730D741-7B6E-45B8-B95A-97D65B3D8D5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AF8E071-FA9C-4318-8CA4-24AD8A76E8A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3E7C7F-A204-479F-A9CC-71276B26CB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415FEA-7078-480A-A7F0-C1A3932CE7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F7A7DC-D9A0-4442-9524-5DA13B1FC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516155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5A9A57-65AF-4C0D-846A-A0CF986AE15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30A7B88-42B1-4E4F-B0BE-ACD0572F85F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50A7E4-5A31-469B-8CC6-84AA50D6A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DB53BB-6CAB-4738-8E2B-A8703653B5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75801C-F979-4D4D-8930-618E7D6379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0215191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91CBEC-4F65-4476-9A5E-DE055C244D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B7B2A45-BCA3-471E-BE67-FD1CC950E30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962680-4B22-48DF-8A7B-A99795C96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46CD5E-1444-4D28-AB02-E0039D6FFD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AEC0F1-E9E5-4B61-9DC8-6B38226EFF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764928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D640B4-5610-4348-B59B-31E3C61CD5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E9F404A-CB41-46A7-ADEA-BCDDAF4789DD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494971-1CC9-4515-93C5-376C4ADABB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743B1B1-271C-4E68-8347-7B2F1D11DE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54C615-141B-4D11-B2BF-150DE5CEE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C44FC5E-30B2-45C1-AF31-66B7D8D594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96976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EBEAB-94A9-405A-B955-3100C729A93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A9496C-8252-4AFB-9CD3-4A7CB4D4F2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7EA1990-E533-439B-AF43-E62D6C2769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01A4C9E-D1C2-4082-8791-B3AC5D956C2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5D06A9-DA05-4826-9F35-DD802F68BF2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8C5FCC-F28F-4595-85D8-A3B9019753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BB689F-A7B4-4F54-9C45-DCFDEF7A7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E74BDBF-9007-4CC2-A287-E5BCF593149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58522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9B23E8-A8FA-4A42-9DDD-DC8385F806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A5B71BF-6DBD-49ED-9223-747E7D11B7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AF4B551-0848-46B6-98D9-C1EE551BCC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05742A-70CA-4E8B-96B8-4CE5CB390F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88244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1FEE0BE-91E8-4544-A153-B2A118D362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E1CFE53-B487-44D8-A2BC-434236A914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E93EFA-8B01-43A4-B2EF-C0F1D5C968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976464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CD916DC-E08E-4814-92F7-F79658CFC8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30A630C-70EC-470D-9F58-61320233649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9B45BF-8D67-4936-987A-C286E2CE27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DD75B36-8F91-4A12-9E0D-9269E62D5A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20185E4-FE49-4AFD-BBE8-00DDA6860F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234350-6B3E-46C0-8B08-A7E32D9DE8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53867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48ADF89-FA09-4E4A-8D86-9EC97CA25DB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141630E-0972-478B-8B1C-91150810848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61100F0-AAD0-41D8-9CBF-9281155382D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3542F6-8BAA-46A8-B5E4-7BDDB94E24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106A3A0-4199-49E5-BE90-B368D7657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9BB8568-E0F4-42AC-8D4A-A4480982F7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026483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5092DF20-0A05-4FB6-AA94-A14A7707BBF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I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AB2A9E3-88D8-410E-804B-63C344666C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8FC7EA-81D1-4ADD-A0E7-38A2BFF811B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96AA38B-558C-4DE1-A45D-7AC60ACF9210}" type="datetimeFigureOut">
              <a:rPr lang="en-IN" smtClean="0"/>
              <a:t>25-06-2021</a:t>
            </a:fld>
            <a:endParaRPr lang="en-I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1076B0-2A80-4450-B786-E7628553B97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AAE5041-43C4-45B1-841B-EA5E43AEB1E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2C7FBE-EF1B-40B4-A279-C7F5CC017080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2498597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4503967-8B0D-4198-B3F3-96B8943885AC}"/>
              </a:ext>
            </a:extLst>
          </p:cNvPr>
          <p:cNvSpPr txBox="1">
            <a:spLocks/>
          </p:cNvSpPr>
          <p:nvPr/>
        </p:nvSpPr>
        <p:spPr>
          <a:xfrm>
            <a:off x="916527" y="996951"/>
            <a:ext cx="10693400" cy="547370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IN" sz="1600" b="1" dirty="0">
                <a:latin typeface="Arial" panose="020B0604020202020204" pitchFamily="34" charset="0"/>
                <a:ea typeface="Calibri" panose="020F0502020204030204" pitchFamily="34" charset="0"/>
              </a:rPr>
              <a:t>Supplementary Figure 3: hsa-miR-21-5p expression in human microglial cells infected with JEV and CHIKV</a:t>
            </a:r>
            <a:endParaRPr lang="en-IN" sz="1600" dirty="0"/>
          </a:p>
        </p:txBody>
      </p:sp>
      <p:pic>
        <p:nvPicPr>
          <p:cNvPr id="3" name="Picture 2" descr="Chart&#10;&#10;Description automatically generated with medium confidence">
            <a:extLst>
              <a:ext uri="{FF2B5EF4-FFF2-40B4-BE49-F238E27FC236}">
                <a16:creationId xmlns:a16="http://schemas.microsoft.com/office/drawing/2014/main" id="{4798BB4D-945F-48F6-BED0-2023AA17F47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2073" y="1651379"/>
            <a:ext cx="11027854" cy="45665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138113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15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ha Pandey</dc:creator>
  <cp:lastModifiedBy>Dr. Sunit Singh</cp:lastModifiedBy>
  <cp:revision>6</cp:revision>
  <dcterms:created xsi:type="dcterms:W3CDTF">2021-03-08T04:40:18Z</dcterms:created>
  <dcterms:modified xsi:type="dcterms:W3CDTF">2021-06-25T11:51:05Z</dcterms:modified>
</cp:coreProperties>
</file>